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86" d="100"/>
          <a:sy n="86" d="100"/>
        </p:scale>
        <p:origin x="116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7F79C-7F18-4E5B-874E-4ACD5EBDDAA2}" type="datetimeFigureOut">
              <a:rPr lang="en-US" smtClean="0"/>
              <a:t>6/1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3F9B8-D647-4EC6-AA26-64FEB5A4F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123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7F79C-7F18-4E5B-874E-4ACD5EBDDAA2}" type="datetimeFigureOut">
              <a:rPr lang="en-US" smtClean="0"/>
              <a:t>6/1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3F9B8-D647-4EC6-AA26-64FEB5A4F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63673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7F79C-7F18-4E5B-874E-4ACD5EBDDAA2}" type="datetimeFigureOut">
              <a:rPr lang="en-US" smtClean="0"/>
              <a:t>6/1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3F9B8-D647-4EC6-AA26-64FEB5A4F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9999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7F79C-7F18-4E5B-874E-4ACD5EBDDAA2}" type="datetimeFigureOut">
              <a:rPr lang="en-US" smtClean="0"/>
              <a:t>6/1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3F9B8-D647-4EC6-AA26-64FEB5A4F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9360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7F79C-7F18-4E5B-874E-4ACD5EBDDAA2}" type="datetimeFigureOut">
              <a:rPr lang="en-US" smtClean="0"/>
              <a:t>6/1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3F9B8-D647-4EC6-AA26-64FEB5A4F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13245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7F79C-7F18-4E5B-874E-4ACD5EBDDAA2}" type="datetimeFigureOut">
              <a:rPr lang="en-US" smtClean="0"/>
              <a:t>6/1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3F9B8-D647-4EC6-AA26-64FEB5A4F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6371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7F79C-7F18-4E5B-874E-4ACD5EBDDAA2}" type="datetimeFigureOut">
              <a:rPr lang="en-US" smtClean="0"/>
              <a:t>6/1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3F9B8-D647-4EC6-AA26-64FEB5A4F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43933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7F79C-7F18-4E5B-874E-4ACD5EBDDAA2}" type="datetimeFigureOut">
              <a:rPr lang="en-US" smtClean="0"/>
              <a:t>6/1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3F9B8-D647-4EC6-AA26-64FEB5A4F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5220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7F79C-7F18-4E5B-874E-4ACD5EBDDAA2}" type="datetimeFigureOut">
              <a:rPr lang="en-US" smtClean="0"/>
              <a:t>6/1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3F9B8-D647-4EC6-AA26-64FEB5A4F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6475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7F79C-7F18-4E5B-874E-4ACD5EBDDAA2}" type="datetimeFigureOut">
              <a:rPr lang="en-US" smtClean="0"/>
              <a:t>6/1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3F9B8-D647-4EC6-AA26-64FEB5A4F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47211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7F79C-7F18-4E5B-874E-4ACD5EBDDAA2}" type="datetimeFigureOut">
              <a:rPr lang="en-US" smtClean="0"/>
              <a:t>6/1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23F9B8-D647-4EC6-AA26-64FEB5A4F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7522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67F79C-7F18-4E5B-874E-4ACD5EBDDAA2}" type="datetimeFigureOut">
              <a:rPr lang="en-US" smtClean="0"/>
              <a:t>6/1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23F9B8-D647-4EC6-AA26-64FEB5A4F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4537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33981073"/>
              </p:ext>
            </p:extLst>
          </p:nvPr>
        </p:nvGraphicFramePr>
        <p:xfrm>
          <a:off x="1233162" y="4348468"/>
          <a:ext cx="4570095" cy="411480"/>
        </p:xfrm>
        <a:graphic>
          <a:graphicData uri="http://schemas.openxmlformats.org/drawingml/2006/table">
            <a:tbl>
              <a:tblPr firstRow="1" firstCol="1" bandRow="1"/>
              <a:tblGrid>
                <a:gridCol w="742950"/>
                <a:gridCol w="741045"/>
                <a:gridCol w="3086100"/>
              </a:tblGrid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ITGB3BP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4.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Estrogen–inducible; ER co-activator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ALAT1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143.7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etastasis / Cell invasion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CD4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3.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Cancer stem cell marker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10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67963566"/>
              </p:ext>
            </p:extLst>
          </p:nvPr>
        </p:nvGraphicFramePr>
        <p:xfrm>
          <a:off x="1233161" y="3824362"/>
          <a:ext cx="4570095" cy="411480"/>
        </p:xfrm>
        <a:graphic>
          <a:graphicData uri="http://schemas.openxmlformats.org/drawingml/2006/table">
            <a:tbl>
              <a:tblPr firstRow="1" firstCol="1" bandRow="1"/>
              <a:tblGrid>
                <a:gridCol w="742950"/>
                <a:gridCol w="741045"/>
                <a:gridCol w="3086100"/>
              </a:tblGrid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ALCAM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3.5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Metastasis / Cell invasion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GLN3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8.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Cell proliferation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ITGB1BP1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4.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Cell proliferation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18171805"/>
              </p:ext>
            </p:extLst>
          </p:nvPr>
        </p:nvGraphicFramePr>
        <p:xfrm>
          <a:off x="1233160" y="3224056"/>
          <a:ext cx="4570095" cy="487680"/>
        </p:xfrm>
        <a:graphic>
          <a:graphicData uri="http://schemas.openxmlformats.org/drawingml/2006/table">
            <a:tbl>
              <a:tblPr firstRow="1" firstCol="1" bandRow="1"/>
              <a:tblGrid>
                <a:gridCol w="742950"/>
                <a:gridCol w="741045"/>
                <a:gridCol w="3086100"/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Gene 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Fold expression (WHIM17 vs. Control)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</a:rPr>
                        <a:t>Biological Role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2" name="Rectangle 11"/>
          <p:cNvSpPr/>
          <p:nvPr/>
        </p:nvSpPr>
        <p:spPr>
          <a:xfrm>
            <a:off x="2023265" y="1783064"/>
            <a:ext cx="209384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 smtClean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table 2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841428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46</Words>
  <Application>Microsoft Office PowerPoint</Application>
  <PresentationFormat>On-screen Show (4:3)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IT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eeraj, Gopinathan Pillai</dc:creator>
  <cp:lastModifiedBy>Sreeraj, Gopinathan Pillai</cp:lastModifiedBy>
  <cp:revision>2</cp:revision>
  <dcterms:created xsi:type="dcterms:W3CDTF">2017-06-19T15:07:03Z</dcterms:created>
  <dcterms:modified xsi:type="dcterms:W3CDTF">2017-06-19T15:37:40Z</dcterms:modified>
</cp:coreProperties>
</file>